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4902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8031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37712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14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59701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8102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7000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6657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0346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6337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7918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51803-F9FB-4924-A91D-77A1981A1D6D}" type="datetimeFigureOut">
              <a:rPr lang="en-AU" smtClean="0"/>
              <a:t>6/1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498D5-23E3-4FBE-8A45-A0922947E1A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4238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532" y="781993"/>
            <a:ext cx="10719464" cy="4810257"/>
          </a:xfrm>
          <a:prstGeom prst="rect">
            <a:avLst/>
          </a:prstGeom>
        </p:spPr>
      </p:pic>
      <p:cxnSp>
        <p:nvCxnSpPr>
          <p:cNvPr id="29" name="Straight Connector 28"/>
          <p:cNvCxnSpPr/>
          <p:nvPr/>
        </p:nvCxnSpPr>
        <p:spPr>
          <a:xfrm>
            <a:off x="1104931" y="5536276"/>
            <a:ext cx="101920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1104931" y="2770904"/>
            <a:ext cx="10192065" cy="6373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095897" y="2812469"/>
            <a:ext cx="2352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DNA Content (DAPI)</a:t>
            </a:r>
            <a:endParaRPr lang="en-AU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5095897" y="5536272"/>
            <a:ext cx="23525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DNA Content (DAPI)</a:t>
            </a:r>
            <a:endParaRPr lang="en-AU" b="1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362101" y="1404276"/>
            <a:ext cx="750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BrdU</a:t>
            </a:r>
            <a:endParaRPr lang="en-AU" b="1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335782" y="4040794"/>
            <a:ext cx="819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BrdU</a:t>
            </a:r>
            <a:endParaRPr lang="en-AU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463039" y="600826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0 Gy-1 hr</a:t>
            </a:r>
            <a:endParaRPr lang="en-AU" sz="16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829098" y="592513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/>
              <a:t>1</a:t>
            </a:r>
            <a:r>
              <a:rPr lang="en-AU" sz="1600" b="1" dirty="0" smtClean="0"/>
              <a:t> Gy-72 hr</a:t>
            </a:r>
            <a:endParaRPr lang="en-AU" sz="1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243904" y="592513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2 Gy-72 hr</a:t>
            </a:r>
            <a:endParaRPr lang="en-AU" sz="16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5702726" y="584201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/>
              <a:t>4</a:t>
            </a:r>
            <a:r>
              <a:rPr lang="en-AU" sz="1600" b="1" dirty="0" smtClean="0"/>
              <a:t> Gy-72 hr</a:t>
            </a:r>
            <a:endParaRPr lang="en-AU" sz="16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7111894" y="592513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8 Gy-72 hr</a:t>
            </a:r>
            <a:endParaRPr lang="en-AU" sz="16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8529375" y="589533"/>
            <a:ext cx="1184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16 Gy-72 hr</a:t>
            </a:r>
            <a:endParaRPr lang="en-AU" sz="1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9946636" y="589533"/>
            <a:ext cx="1184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72 hr</a:t>
            </a:r>
            <a:endParaRPr lang="en-AU" sz="16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1490748" y="3261151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0 Gy-1 hr</a:t>
            </a:r>
            <a:endParaRPr lang="en-AU" sz="1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197629" y="3244525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1 hr</a:t>
            </a:r>
            <a:endParaRPr lang="en-AU" sz="1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4887883" y="3244525"/>
            <a:ext cx="1155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6 hr</a:t>
            </a:r>
            <a:endParaRPr lang="en-AU" sz="1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6452259" y="3241795"/>
            <a:ext cx="1228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24 hr</a:t>
            </a:r>
            <a:endParaRPr lang="en-AU" sz="1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8125888" y="3233482"/>
            <a:ext cx="1228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48 hr</a:t>
            </a:r>
            <a:endParaRPr lang="en-AU" sz="1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9838987" y="3230292"/>
            <a:ext cx="1228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32 Gy-72 hr</a:t>
            </a:r>
            <a:endParaRPr lang="en-AU" sz="16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637310" y="575888"/>
            <a:ext cx="6317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 smtClean="0"/>
              <a:t>A.</a:t>
            </a:r>
            <a:endParaRPr lang="en-AU" sz="20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579120" y="3205817"/>
            <a:ext cx="486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b="1" dirty="0"/>
              <a:t>B</a:t>
            </a:r>
            <a:r>
              <a:rPr lang="en-AU" sz="2000" b="1" dirty="0" smtClean="0"/>
              <a:t>.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4139654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89216" y="1836901"/>
            <a:ext cx="9310254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1055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just">
              <a:lnSpc>
                <a:spcPct val="200000"/>
              </a:lnSpc>
            </a:pPr>
            <a:r>
              <a:rPr kumimoji="0" lang="en-AU" altLang="en-US" sz="1200" b="1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3: The inhibitory effects of photon radiation on cell proliferation are dose and time dependent .</a:t>
            </a:r>
            <a:r>
              <a:rPr lang="en-AU" altLang="en-US" sz="1200" b="1" dirty="0" smtClean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altLang="en-US" sz="1200" b="1" dirty="0"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flow cytometry data from irradiated AB1 cells, showing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ptake vs DNA content (DAPI). Gating for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kumimoji="0" lang="en-AU" altLang="en-US" sz="1200" b="0" i="0" strike="noStrike" cap="none" normalizeH="0" baseline="3000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ells were actively proliferating during 1hr pulse period leading up to specified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mepoints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altLang="en-US" sz="1200" dirty="0"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ed on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rdU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AU" altLang="en-US" sz="1200" b="0" i="1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s.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PI. Higher dose radiation from 8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hibits cell proliferation better than dose of 1, 2 and 4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Doses above 8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e a longer-lasting inhibition of </a:t>
            </a:r>
            <a:r>
              <a:rPr lang="en-AU" altLang="en-US" sz="1200" dirty="0" smtClean="0">
                <a:ea typeface="Calibri" panose="020F0502020204030204" pitchFamily="34" charset="0"/>
                <a:cs typeface="Arial" panose="020B0604020202020204" pitchFamily="34" charset="0"/>
              </a:rPr>
              <a:t>cell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liferation when examined at the 72-hr post-irradiation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mepoint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kumimoji="0" lang="en-AU" altLang="en-US" sz="1200" b="1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delay of at least 6 hours is apparent before the inhibitory effects of radiation on DNA replication can be observed, even at 32 </a:t>
            </a:r>
            <a:r>
              <a:rPr kumimoji="0" lang="en-AU" altLang="en-US" sz="12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kumimoji="0" lang="en-AU" altLang="en-US" sz="1800" b="0" i="0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97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185</Words>
  <Application>Microsoft Office PowerPoint</Application>
  <PresentationFormat>Widescreen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Western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nat Keam</dc:creator>
  <cp:lastModifiedBy>Synat Keam</cp:lastModifiedBy>
  <cp:revision>13</cp:revision>
  <dcterms:created xsi:type="dcterms:W3CDTF">2021-09-05T14:33:19Z</dcterms:created>
  <dcterms:modified xsi:type="dcterms:W3CDTF">2021-11-06T09:00:44Z</dcterms:modified>
</cp:coreProperties>
</file>